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6" d="100"/>
          <a:sy n="96" d="100"/>
        </p:scale>
        <p:origin x="101" y="9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D05D59-6390-46DC-8F37-E1A79B92A1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CB55A6C-4786-40E2-B261-B338965FB8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8AA87A-54A1-4E5C-BC2F-714EC8EB5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E208BB-423B-4387-B63A-A9217D20D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5E3254-0F1B-4499-8EB7-052DFCAC3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60071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7654C1-1220-4661-9986-27162AA773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5F8116-9019-4635-89F6-15A68DD774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35670C-04B1-486B-AC28-626D4E191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C79A1A-3879-4805-A2B4-9588195AF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6EA068-FBDA-4AA6-B6EB-F11DB4071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07320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E9BAE1-7791-407E-8D57-2894AB355A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AA5EB4-5A7E-478F-8B1A-F5695205F8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9BBFE9-CB79-4510-BE0C-B8A097E47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A04B47-C980-41EB-9B0C-B94F4B309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0E95B2-8333-412A-865D-E417E3A83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94322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5C2F30-72FC-4E73-86AA-7B98BA10A4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9D2A62-2F80-408E-86E0-55B052C7DD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990970-4349-4061-A6B4-93F15D307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7706A1-5491-438C-B269-C70E08F3C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0D28A4-7FBE-4E4E-8551-356984EFF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1896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8EAC71-6220-45CF-8173-AF5ECA2E8B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BDD928-FA00-41A3-9EB7-659C014486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CC4BA9-26D5-4E22-B070-48B24E264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DD650F-1027-45A5-B375-6A30604AB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D47E66-FF80-40B9-802D-5F51CA038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39151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DB0E14-54A5-4283-9AB4-3B373967C3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7226CC-B4FC-4CAE-A15E-2CB2056279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DF4332-B9A7-4D10-B473-8EEE472241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96D967-6EBB-4C38-B618-C2B83C2A0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59085B-A141-4E7F-AB14-9D0D322EC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1635BB-892E-46DC-A141-79D7387A2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51905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88CC7C-864F-4533-A6EA-30B9CF8E81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4AF464-731F-438A-B67E-8E9F541402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5A8AA1-F2AD-4635-9041-EF4D15900B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5B0BC3-6024-4851-9ECE-5048694EEC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9F24564-F9D1-4AF8-A0DB-E04667DD7F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627CFD-F7AE-4D09-88C5-41E7D4591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2D4D2D3-A63E-4B58-A99E-F218CE0F7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17676A-BD42-460F-8B88-20E0B167D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77820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F6FA79-EAA9-43A4-A1DA-772667B610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8443786-2EAE-4529-AC44-FD7B9ABBA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05575F6-6560-423C-8BEC-673F1471B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135A4C-FDB0-46EE-9924-A5AB319E1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14085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C0189EF-D620-4F37-8AB3-34F58EBFE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8E5D75-0E5B-474E-AF4B-A347EFB45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B29070-D309-4F86-AB45-F25E981F6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030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B7163C-8596-4926-AA28-98DD7156AF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BCB9BB-E770-4A71-A829-7863FE8790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1DF7C7-667E-4293-93DB-7580797C28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587DA2-F69B-418B-AA35-6BBF2995E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D6175E-F40D-4EE1-96C2-19D42C79C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436D60-FE1A-4117-B6A1-643ABF86D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65859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B8999B-A778-4039-A28C-B3B063AE28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5E2150-DD24-42EA-9843-9A837F661A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5A0557-B404-4872-9F1E-10F136638B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9ED799-477C-42D7-B86C-E9680EBDF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87EC6B-2421-45EF-9BE4-30BBB3688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B33D63-D4F2-48F9-B65D-A4E6BF8DA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39311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18C8B1-57C7-4D0E-8AF8-92012E26DA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89DF21-6EA2-4B04-8E5E-0ABB51902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FE2069-C57D-4C09-A6D0-3D8296EE56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A0004-E84C-4D0C-8296-B707E4D40072}" type="datetimeFigureOut">
              <a:rPr lang="en-IN" smtClean="0"/>
              <a:pPr/>
              <a:t>06-0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057D72-6CF5-42E5-9147-FDE96B4E90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0731A9-DC31-4B88-ACA1-4F44447812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E657E-B6B4-4B15-B129-B69CD1D3E971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67355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3AEC001-3BC3-4CDA-8A7B-6347B03C1B72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35938" y="1196877"/>
            <a:ext cx="4505553" cy="441111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647F2E0-0E4E-4D80-A724-0CCE59A48217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004482" y="1190032"/>
            <a:ext cx="4415837" cy="439008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DB2B892-4807-4CE0-BEE2-827C68AFB3CC}"/>
              </a:ext>
            </a:extLst>
          </p:cNvPr>
          <p:cNvSpPr txBox="1"/>
          <p:nvPr/>
        </p:nvSpPr>
        <p:spPr>
          <a:xfrm>
            <a:off x="71718" y="46837"/>
            <a:ext cx="121202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1</a:t>
            </a:r>
            <a:endParaRPr lang="en-IN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6D9132C-04ED-41D2-A932-A8845C91BDBF}"/>
              </a:ext>
            </a:extLst>
          </p:cNvPr>
          <p:cNvSpPr txBox="1"/>
          <p:nvPr/>
        </p:nvSpPr>
        <p:spPr>
          <a:xfrm>
            <a:off x="1635938" y="577605"/>
            <a:ext cx="45055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IN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.1: Almond preload Treatment diet</a:t>
            </a:r>
            <a:endParaRPr lang="en-IN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B3DFE03-F46E-462D-AB0D-608F75E79A4A}"/>
              </a:ext>
            </a:extLst>
          </p:cNvPr>
          <p:cNvSpPr txBox="1"/>
          <p:nvPr/>
        </p:nvSpPr>
        <p:spPr>
          <a:xfrm>
            <a:off x="8042733" y="642280"/>
            <a:ext cx="28647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IN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.2: Control diet</a:t>
            </a:r>
            <a:endParaRPr lang="en-IN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1245329" y="1184173"/>
            <a:ext cx="583474" cy="1218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≥4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3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2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1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≤40</a:t>
            </a:r>
          </a:p>
        </p:txBody>
      </p:sp>
      <p:sp>
        <p:nvSpPr>
          <p:cNvPr id="10" name="Rectangle 9"/>
          <p:cNvSpPr/>
          <p:nvPr/>
        </p:nvSpPr>
        <p:spPr>
          <a:xfrm>
            <a:off x="1254036" y="2734314"/>
            <a:ext cx="583474" cy="1218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≥4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3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2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1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≤40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210497" y="4284423"/>
            <a:ext cx="583474" cy="1218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≥4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3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2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100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≤4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30B9659-AB2F-5471-42D3-987F4D6892F2}"/>
              </a:ext>
            </a:extLst>
          </p:cNvPr>
          <p:cNvSpPr txBox="1"/>
          <p:nvPr/>
        </p:nvSpPr>
        <p:spPr>
          <a:xfrm>
            <a:off x="532737" y="5828306"/>
            <a:ext cx="11195437" cy="15286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:  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ree-day continuous glucose monitoring data of a 41-year-old male with prediabetes on almond preload treatment (4.1) and control diet (4.2). Note lower blood glucose excursions in figure 4.1</a:t>
            </a:r>
            <a:r>
              <a:rPr lang="en-IN" sz="1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s.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.2​ ​. 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​The X-axis shows time in ​2-hour ​intervals for 24 hours and ​the ​​Y-axis shows blood glucose (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ol/L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from 2.2-22.2 mmol/L in each graph tracing.  ​The shaded area ​shows blood glucose ​ of ​3.9 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ol/L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limit of the shaded area below) to 7.8 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ol/L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limit of the shaded area above). The continuous line depicts blood glucose values evaluated by the sensor. The symbols in the shaded area show the following: The circles with a dot inside show the blood glucose values evaluated by the glucose meter (Contour Plus One blood glucose meter,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censia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iabetes Care Holdings AG, Switzerland). A small cartoon of a person walking depicts exercise time. Two oblong hollows (fork and knife) in ​the ​cartoon indicate small ​snacks such as premeal almond load and shaded oblongs indicate major meals (breakfast, lunch, or dinner)</a:t>
            </a:r>
            <a:endParaRPr lang="en-IN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IN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N" sz="1000" dirty="0"/>
          </a:p>
        </p:txBody>
      </p:sp>
    </p:spTree>
    <p:extLst>
      <p:ext uri="{BB962C8B-B14F-4D97-AF65-F5344CB8AC3E}">
        <p14:creationId xmlns:p14="http://schemas.microsoft.com/office/powerpoint/2010/main" val="1155429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53</TotalTime>
  <Words>25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emagulati2007@gmail.com</dc:creator>
  <cp:lastModifiedBy>Seema Gulati</cp:lastModifiedBy>
  <cp:revision>18</cp:revision>
  <dcterms:created xsi:type="dcterms:W3CDTF">2021-12-02T08:08:46Z</dcterms:created>
  <dcterms:modified xsi:type="dcterms:W3CDTF">2023-01-06T08:06:40Z</dcterms:modified>
</cp:coreProperties>
</file>